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744"/>
  </p:normalViewPr>
  <p:slideViewPr>
    <p:cSldViewPr snapToGrid="0" snapToObjects="1">
      <p:cViewPr>
        <p:scale>
          <a:sx n="72" d="100"/>
          <a:sy n="72" d="100"/>
        </p:scale>
        <p:origin x="2648" y="4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5ED37B-481D-464A-A885-EE3AD49A1706}" type="datetimeFigureOut">
              <a:rPr lang="en-CH" smtClean="0"/>
              <a:t>13.04.22</a:t>
            </a:fld>
            <a:endParaRPr lang="en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7C4F8-C1D8-0B4C-8992-66C76A437029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7885204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5ED37B-481D-464A-A885-EE3AD49A1706}" type="datetimeFigureOut">
              <a:rPr lang="en-CH" smtClean="0"/>
              <a:t>13.04.22</a:t>
            </a:fld>
            <a:endParaRPr lang="en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7C4F8-C1D8-0B4C-8992-66C76A437029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19882586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5ED37B-481D-464A-A885-EE3AD49A1706}" type="datetimeFigureOut">
              <a:rPr lang="en-CH" smtClean="0"/>
              <a:t>13.04.22</a:t>
            </a:fld>
            <a:endParaRPr lang="en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7C4F8-C1D8-0B4C-8992-66C76A437029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1478665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5ED37B-481D-464A-A885-EE3AD49A1706}" type="datetimeFigureOut">
              <a:rPr lang="en-CH" smtClean="0"/>
              <a:t>13.04.22</a:t>
            </a:fld>
            <a:endParaRPr lang="en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7C4F8-C1D8-0B4C-8992-66C76A437029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30032414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5ED37B-481D-464A-A885-EE3AD49A1706}" type="datetimeFigureOut">
              <a:rPr lang="en-CH" smtClean="0"/>
              <a:t>13.04.22</a:t>
            </a:fld>
            <a:endParaRPr lang="en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7C4F8-C1D8-0B4C-8992-66C76A437029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10867624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5ED37B-481D-464A-A885-EE3AD49A1706}" type="datetimeFigureOut">
              <a:rPr lang="en-CH" smtClean="0"/>
              <a:t>13.04.22</a:t>
            </a:fld>
            <a:endParaRPr lang="en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7C4F8-C1D8-0B4C-8992-66C76A437029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6432419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5ED37B-481D-464A-A885-EE3AD49A1706}" type="datetimeFigureOut">
              <a:rPr lang="en-CH" smtClean="0"/>
              <a:t>13.04.22</a:t>
            </a:fld>
            <a:endParaRPr lang="en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7C4F8-C1D8-0B4C-8992-66C76A437029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34604738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5ED37B-481D-464A-A885-EE3AD49A1706}" type="datetimeFigureOut">
              <a:rPr lang="en-CH" smtClean="0"/>
              <a:t>13.04.22</a:t>
            </a:fld>
            <a:endParaRPr lang="en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7C4F8-C1D8-0B4C-8992-66C76A437029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24642978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5ED37B-481D-464A-A885-EE3AD49A1706}" type="datetimeFigureOut">
              <a:rPr lang="en-CH" smtClean="0"/>
              <a:t>13.04.22</a:t>
            </a:fld>
            <a:endParaRPr lang="en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7C4F8-C1D8-0B4C-8992-66C76A437029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11321980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5ED37B-481D-464A-A885-EE3AD49A1706}" type="datetimeFigureOut">
              <a:rPr lang="en-CH" smtClean="0"/>
              <a:t>13.04.22</a:t>
            </a:fld>
            <a:endParaRPr lang="en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7C4F8-C1D8-0B4C-8992-66C76A437029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40529775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5ED37B-481D-464A-A885-EE3AD49A1706}" type="datetimeFigureOut">
              <a:rPr lang="en-CH" smtClean="0"/>
              <a:t>13.04.22</a:t>
            </a:fld>
            <a:endParaRPr lang="en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7C4F8-C1D8-0B4C-8992-66C76A437029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19072502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5ED37B-481D-464A-A885-EE3AD49A1706}" type="datetimeFigureOut">
              <a:rPr lang="en-CH" smtClean="0"/>
              <a:t>13.04.22</a:t>
            </a:fld>
            <a:endParaRPr lang="en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97C4F8-C1D8-0B4C-8992-66C76A437029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33147381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66B35CD-7E8A-9B45-A77C-CB26A8ED1A0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957" b="2199"/>
          <a:stretch/>
        </p:blipFill>
        <p:spPr>
          <a:xfrm flipH="1">
            <a:off x="179959" y="209157"/>
            <a:ext cx="6586597" cy="9629900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A661D187-03CC-6B47-9A75-B2539DC23682}"/>
              </a:ext>
            </a:extLst>
          </p:cNvPr>
          <p:cNvSpPr/>
          <p:nvPr/>
        </p:nvSpPr>
        <p:spPr>
          <a:xfrm>
            <a:off x="163918" y="3727014"/>
            <a:ext cx="2999874" cy="43634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H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BCAA136F-B332-0448-83E6-05E0F3EB4FD5}"/>
              </a:ext>
            </a:extLst>
          </p:cNvPr>
          <p:cNvSpPr/>
          <p:nvPr/>
        </p:nvSpPr>
        <p:spPr>
          <a:xfrm>
            <a:off x="163917" y="366194"/>
            <a:ext cx="6432885" cy="28153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H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E25B19C2-2962-3D48-A084-1912507492E8}"/>
              </a:ext>
            </a:extLst>
          </p:cNvPr>
          <p:cNvSpPr/>
          <p:nvPr/>
        </p:nvSpPr>
        <p:spPr>
          <a:xfrm>
            <a:off x="3396401" y="3245752"/>
            <a:ext cx="3200401" cy="657943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H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420552F-6AFB-E542-A2F5-E8015852B800}"/>
              </a:ext>
            </a:extLst>
          </p:cNvPr>
          <p:cNvSpPr txBox="1"/>
          <p:nvPr/>
        </p:nvSpPr>
        <p:spPr>
          <a:xfrm>
            <a:off x="2512664" y="7723454"/>
            <a:ext cx="6671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dirty="0"/>
              <a:t>Actin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BD78B39-2CDF-394B-9A05-7F4FC8ACB911}"/>
              </a:ext>
            </a:extLst>
          </p:cNvPr>
          <p:cNvSpPr txBox="1"/>
          <p:nvPr/>
        </p:nvSpPr>
        <p:spPr>
          <a:xfrm>
            <a:off x="5817338" y="9455857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dirty="0"/>
              <a:t>PSD9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5BF6C83-9335-DB49-BCD2-C6A61C65E6F5}"/>
              </a:ext>
            </a:extLst>
          </p:cNvPr>
          <p:cNvSpPr txBox="1"/>
          <p:nvPr/>
        </p:nvSpPr>
        <p:spPr>
          <a:xfrm>
            <a:off x="6067681" y="393641"/>
            <a:ext cx="5229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dirty="0"/>
              <a:t>Alix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1BE24463-9924-5F4B-A4FD-6F12A90C2BAA}"/>
              </a:ext>
            </a:extLst>
          </p:cNvPr>
          <p:cNvCxnSpPr>
            <a:cxnSpLocks/>
          </p:cNvCxnSpPr>
          <p:nvPr/>
        </p:nvCxnSpPr>
        <p:spPr>
          <a:xfrm flipH="1">
            <a:off x="2097677" y="1168479"/>
            <a:ext cx="253219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731298AA-E063-104E-A50C-37C3E9B5B6D7}"/>
              </a:ext>
            </a:extLst>
          </p:cNvPr>
          <p:cNvCxnSpPr>
            <a:cxnSpLocks/>
          </p:cNvCxnSpPr>
          <p:nvPr/>
        </p:nvCxnSpPr>
        <p:spPr>
          <a:xfrm flipH="1">
            <a:off x="5464829" y="1812933"/>
            <a:ext cx="253219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E72E0F87-D652-C548-ADFA-B6B017E9C113}"/>
              </a:ext>
            </a:extLst>
          </p:cNvPr>
          <p:cNvCxnSpPr>
            <a:cxnSpLocks/>
          </p:cNvCxnSpPr>
          <p:nvPr/>
        </p:nvCxnSpPr>
        <p:spPr>
          <a:xfrm flipH="1">
            <a:off x="5408609" y="4228780"/>
            <a:ext cx="253219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DA73E157-A300-8B46-8D7D-179E3D381DC7}"/>
              </a:ext>
            </a:extLst>
          </p:cNvPr>
          <p:cNvCxnSpPr>
            <a:cxnSpLocks/>
          </p:cNvCxnSpPr>
          <p:nvPr/>
        </p:nvCxnSpPr>
        <p:spPr>
          <a:xfrm flipH="1">
            <a:off x="5155390" y="6657000"/>
            <a:ext cx="253219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448B3E2B-5F10-7546-B533-DCE653BA1A1B}"/>
              </a:ext>
            </a:extLst>
          </p:cNvPr>
          <p:cNvCxnSpPr>
            <a:cxnSpLocks/>
          </p:cNvCxnSpPr>
          <p:nvPr/>
        </p:nvCxnSpPr>
        <p:spPr>
          <a:xfrm flipH="1">
            <a:off x="5211610" y="8552091"/>
            <a:ext cx="253219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5CE7E585-4A62-344A-9A3A-24C352DE99CE}"/>
              </a:ext>
            </a:extLst>
          </p:cNvPr>
          <p:cNvCxnSpPr>
            <a:cxnSpLocks/>
          </p:cNvCxnSpPr>
          <p:nvPr/>
        </p:nvCxnSpPr>
        <p:spPr>
          <a:xfrm flipH="1">
            <a:off x="1953446" y="7039709"/>
            <a:ext cx="253219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88170612-F453-754D-8150-878027C5E870}"/>
              </a:ext>
            </a:extLst>
          </p:cNvPr>
          <p:cNvCxnSpPr>
            <a:cxnSpLocks/>
          </p:cNvCxnSpPr>
          <p:nvPr/>
        </p:nvCxnSpPr>
        <p:spPr>
          <a:xfrm flipH="1">
            <a:off x="2138649" y="4719539"/>
            <a:ext cx="253219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A4EE909A-84B9-2B42-B0CF-2F894D6EC27D}"/>
              </a:ext>
            </a:extLst>
          </p:cNvPr>
          <p:cNvSpPr txBox="1"/>
          <p:nvPr/>
        </p:nvSpPr>
        <p:spPr>
          <a:xfrm>
            <a:off x="592775" y="594167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400" dirty="0"/>
              <a:t>3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A185BCA-9F76-1744-B3C5-016193DBAF84}"/>
              </a:ext>
            </a:extLst>
          </p:cNvPr>
          <p:cNvSpPr txBox="1"/>
          <p:nvPr/>
        </p:nvSpPr>
        <p:spPr>
          <a:xfrm>
            <a:off x="909808" y="592365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400" dirty="0"/>
              <a:t>6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8DFE567-3DEA-344F-9214-91B03BA56BDF}"/>
              </a:ext>
            </a:extLst>
          </p:cNvPr>
          <p:cNvSpPr txBox="1"/>
          <p:nvPr/>
        </p:nvSpPr>
        <p:spPr>
          <a:xfrm>
            <a:off x="1224756" y="592365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400" dirty="0"/>
              <a:t>9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A034224-0F78-B145-94BE-F8E19DC30523}"/>
              </a:ext>
            </a:extLst>
          </p:cNvPr>
          <p:cNvSpPr txBox="1"/>
          <p:nvPr/>
        </p:nvSpPr>
        <p:spPr>
          <a:xfrm>
            <a:off x="1454066" y="592365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400" dirty="0"/>
              <a:t>12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3624B08-51E5-DD41-BBCC-B1AD738A5DED}"/>
              </a:ext>
            </a:extLst>
          </p:cNvPr>
          <p:cNvSpPr txBox="1"/>
          <p:nvPr/>
        </p:nvSpPr>
        <p:spPr>
          <a:xfrm>
            <a:off x="1731990" y="594167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400" dirty="0"/>
              <a:t>15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DE4F33D-63E1-5141-AACB-9A7B18E60EE3}"/>
              </a:ext>
            </a:extLst>
          </p:cNvPr>
          <p:cNvSpPr txBox="1"/>
          <p:nvPr/>
        </p:nvSpPr>
        <p:spPr>
          <a:xfrm>
            <a:off x="3958206" y="1171649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400" dirty="0"/>
              <a:t>3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EF744B0-3B86-7340-A745-86EFBFF7BE59}"/>
              </a:ext>
            </a:extLst>
          </p:cNvPr>
          <p:cNvSpPr txBox="1"/>
          <p:nvPr/>
        </p:nvSpPr>
        <p:spPr>
          <a:xfrm>
            <a:off x="4275239" y="1169847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400" dirty="0"/>
              <a:t>6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0FD2D3B-EA09-6D4C-8CC1-F5D0D6EBD405}"/>
              </a:ext>
            </a:extLst>
          </p:cNvPr>
          <p:cNvSpPr txBox="1"/>
          <p:nvPr/>
        </p:nvSpPr>
        <p:spPr>
          <a:xfrm>
            <a:off x="4590187" y="1169847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400" dirty="0"/>
              <a:t>9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2397497-8DE1-DE44-B4BE-D027BBAB864E}"/>
              </a:ext>
            </a:extLst>
          </p:cNvPr>
          <p:cNvSpPr txBox="1"/>
          <p:nvPr/>
        </p:nvSpPr>
        <p:spPr>
          <a:xfrm>
            <a:off x="4819497" y="1169847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400" dirty="0"/>
              <a:t>12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EF3D999-475E-6343-9615-E426058168DC}"/>
              </a:ext>
            </a:extLst>
          </p:cNvPr>
          <p:cNvSpPr txBox="1"/>
          <p:nvPr/>
        </p:nvSpPr>
        <p:spPr>
          <a:xfrm>
            <a:off x="5097421" y="1171649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400" dirty="0"/>
              <a:t>15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8FBD223-691F-CA45-B694-C49EA9E2BA33}"/>
              </a:ext>
            </a:extLst>
          </p:cNvPr>
          <p:cNvSpPr txBox="1"/>
          <p:nvPr/>
        </p:nvSpPr>
        <p:spPr>
          <a:xfrm>
            <a:off x="3976106" y="3784925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400" dirty="0"/>
              <a:t>3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35747BF5-6BBC-1840-967E-F1F47379DAFE}"/>
              </a:ext>
            </a:extLst>
          </p:cNvPr>
          <p:cNvSpPr txBox="1"/>
          <p:nvPr/>
        </p:nvSpPr>
        <p:spPr>
          <a:xfrm>
            <a:off x="4214763" y="3783123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400" dirty="0"/>
              <a:t>6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D977D165-01B9-5048-9B17-4709F460A632}"/>
              </a:ext>
            </a:extLst>
          </p:cNvPr>
          <p:cNvSpPr txBox="1"/>
          <p:nvPr/>
        </p:nvSpPr>
        <p:spPr>
          <a:xfrm>
            <a:off x="4490523" y="3783123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400" dirty="0"/>
              <a:t>9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3DE35B3D-B046-0A41-A502-65A943790189}"/>
              </a:ext>
            </a:extLst>
          </p:cNvPr>
          <p:cNvSpPr txBox="1"/>
          <p:nvPr/>
        </p:nvSpPr>
        <p:spPr>
          <a:xfrm>
            <a:off x="4759021" y="3783123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400" dirty="0"/>
              <a:t>12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68D79883-6CE5-D94C-A4C8-8CEBC6905CCE}"/>
              </a:ext>
            </a:extLst>
          </p:cNvPr>
          <p:cNvSpPr txBox="1"/>
          <p:nvPr/>
        </p:nvSpPr>
        <p:spPr>
          <a:xfrm>
            <a:off x="5036945" y="3784925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400" dirty="0"/>
              <a:t>15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8A1A9393-482D-FB46-811A-2D9FF5368560}"/>
              </a:ext>
            </a:extLst>
          </p:cNvPr>
          <p:cNvSpPr txBox="1"/>
          <p:nvPr/>
        </p:nvSpPr>
        <p:spPr>
          <a:xfrm>
            <a:off x="3705722" y="6156038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400" dirty="0"/>
              <a:t>3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1E0C7DE-416B-A749-AC07-34F541BD0F7F}"/>
              </a:ext>
            </a:extLst>
          </p:cNvPr>
          <p:cNvSpPr txBox="1"/>
          <p:nvPr/>
        </p:nvSpPr>
        <p:spPr>
          <a:xfrm>
            <a:off x="3944379" y="6154236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400" dirty="0"/>
              <a:t>6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2BDC8D76-C668-6D4D-BBC0-8540BEF4905B}"/>
              </a:ext>
            </a:extLst>
          </p:cNvPr>
          <p:cNvSpPr txBox="1"/>
          <p:nvPr/>
        </p:nvSpPr>
        <p:spPr>
          <a:xfrm>
            <a:off x="4220139" y="6154236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400" dirty="0"/>
              <a:t>9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9E2591A4-2CF2-414B-9739-EC4B581F25F7}"/>
              </a:ext>
            </a:extLst>
          </p:cNvPr>
          <p:cNvSpPr txBox="1"/>
          <p:nvPr/>
        </p:nvSpPr>
        <p:spPr>
          <a:xfrm>
            <a:off x="4488637" y="6154236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400" dirty="0"/>
              <a:t>12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F09E2B74-A124-9C48-A887-E740E9BDD08F}"/>
              </a:ext>
            </a:extLst>
          </p:cNvPr>
          <p:cNvSpPr txBox="1"/>
          <p:nvPr/>
        </p:nvSpPr>
        <p:spPr>
          <a:xfrm>
            <a:off x="4766561" y="6156038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400" dirty="0"/>
              <a:t>15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8DC425A0-4D71-D74F-9E68-D2A93C60BA33}"/>
              </a:ext>
            </a:extLst>
          </p:cNvPr>
          <p:cNvSpPr txBox="1"/>
          <p:nvPr/>
        </p:nvSpPr>
        <p:spPr>
          <a:xfrm>
            <a:off x="3669174" y="8090467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400" dirty="0"/>
              <a:t>3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4837C43E-8A94-3144-97BE-B56EEAD2342E}"/>
              </a:ext>
            </a:extLst>
          </p:cNvPr>
          <p:cNvSpPr txBox="1"/>
          <p:nvPr/>
        </p:nvSpPr>
        <p:spPr>
          <a:xfrm>
            <a:off x="3907831" y="8088665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400" dirty="0"/>
              <a:t>6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5DF57C94-AB47-1947-8DEC-CCDA26B706C9}"/>
              </a:ext>
            </a:extLst>
          </p:cNvPr>
          <p:cNvSpPr txBox="1"/>
          <p:nvPr/>
        </p:nvSpPr>
        <p:spPr>
          <a:xfrm>
            <a:off x="4183591" y="8088665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400" dirty="0"/>
              <a:t>9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B7D72316-4AF2-D045-AEE7-70BE5BB6B225}"/>
              </a:ext>
            </a:extLst>
          </p:cNvPr>
          <p:cNvSpPr txBox="1"/>
          <p:nvPr/>
        </p:nvSpPr>
        <p:spPr>
          <a:xfrm>
            <a:off x="4452089" y="8088665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400" dirty="0"/>
              <a:t>12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990185A4-FA23-7A47-A99E-A9296763C925}"/>
              </a:ext>
            </a:extLst>
          </p:cNvPr>
          <p:cNvSpPr txBox="1"/>
          <p:nvPr/>
        </p:nvSpPr>
        <p:spPr>
          <a:xfrm>
            <a:off x="4730013" y="8090467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400" dirty="0"/>
              <a:t>15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C2FF5935-7FD9-0A4A-8CF0-ABC851E428DA}"/>
              </a:ext>
            </a:extLst>
          </p:cNvPr>
          <p:cNvSpPr txBox="1"/>
          <p:nvPr/>
        </p:nvSpPr>
        <p:spPr>
          <a:xfrm>
            <a:off x="591054" y="4246275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400" dirty="0"/>
              <a:t>3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C4AB3D96-25EA-CF42-B9BC-BC5F7ABA5ADF}"/>
              </a:ext>
            </a:extLst>
          </p:cNvPr>
          <p:cNvSpPr txBox="1"/>
          <p:nvPr/>
        </p:nvSpPr>
        <p:spPr>
          <a:xfrm>
            <a:off x="908087" y="4244473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400" dirty="0"/>
              <a:t>6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C13F5B55-E470-2548-B20A-B4006EFCCCC8}"/>
              </a:ext>
            </a:extLst>
          </p:cNvPr>
          <p:cNvSpPr txBox="1"/>
          <p:nvPr/>
        </p:nvSpPr>
        <p:spPr>
          <a:xfrm>
            <a:off x="1223035" y="4244473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400" dirty="0"/>
              <a:t>9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C93E9FF5-6E12-D048-B817-D61236E5F8CD}"/>
              </a:ext>
            </a:extLst>
          </p:cNvPr>
          <p:cNvSpPr txBox="1"/>
          <p:nvPr/>
        </p:nvSpPr>
        <p:spPr>
          <a:xfrm>
            <a:off x="1452345" y="4244473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400" dirty="0"/>
              <a:t>12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9BBB67AD-6743-7F41-81DA-FBFBE005DD71}"/>
              </a:ext>
            </a:extLst>
          </p:cNvPr>
          <p:cNvSpPr txBox="1"/>
          <p:nvPr/>
        </p:nvSpPr>
        <p:spPr>
          <a:xfrm>
            <a:off x="1730269" y="4246275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400" dirty="0"/>
              <a:t>15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28D242F2-61C6-C547-870E-2477CEBF4FB8}"/>
              </a:ext>
            </a:extLst>
          </p:cNvPr>
          <p:cNvSpPr txBox="1"/>
          <p:nvPr/>
        </p:nvSpPr>
        <p:spPr>
          <a:xfrm>
            <a:off x="407350" y="6561963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400" dirty="0"/>
              <a:t>3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47718711-7A27-B345-9FAD-D5C1D119756F}"/>
              </a:ext>
            </a:extLst>
          </p:cNvPr>
          <p:cNvSpPr txBox="1"/>
          <p:nvPr/>
        </p:nvSpPr>
        <p:spPr>
          <a:xfrm>
            <a:off x="724383" y="6560161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400" dirty="0"/>
              <a:t>6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0865E77D-622A-7246-AF04-9934BC7F7E49}"/>
              </a:ext>
            </a:extLst>
          </p:cNvPr>
          <p:cNvSpPr txBox="1"/>
          <p:nvPr/>
        </p:nvSpPr>
        <p:spPr>
          <a:xfrm>
            <a:off x="1039331" y="6560161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400" dirty="0"/>
              <a:t>9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C90EE1FF-7797-F34C-AB11-2198D56DBDA5}"/>
              </a:ext>
            </a:extLst>
          </p:cNvPr>
          <p:cNvSpPr txBox="1"/>
          <p:nvPr/>
        </p:nvSpPr>
        <p:spPr>
          <a:xfrm>
            <a:off x="1268641" y="6560161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400" dirty="0"/>
              <a:t>12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4C302289-71CD-224B-A15C-F6EEC7E0CB04}"/>
              </a:ext>
            </a:extLst>
          </p:cNvPr>
          <p:cNvSpPr txBox="1"/>
          <p:nvPr/>
        </p:nvSpPr>
        <p:spPr>
          <a:xfrm>
            <a:off x="1546565" y="6561963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400" dirty="0"/>
              <a:t>15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F1E2D879-FA45-E542-ABDC-24BB6B2EFEF1}"/>
              </a:ext>
            </a:extLst>
          </p:cNvPr>
          <p:cNvSpPr txBox="1"/>
          <p:nvPr/>
        </p:nvSpPr>
        <p:spPr>
          <a:xfrm>
            <a:off x="0" y="-4175"/>
            <a:ext cx="68579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H" sz="1600" dirty="0"/>
              <a:t>Uncropped western blot from figure 1A</a:t>
            </a:r>
          </a:p>
        </p:txBody>
      </p:sp>
    </p:spTree>
    <p:extLst>
      <p:ext uri="{BB962C8B-B14F-4D97-AF65-F5344CB8AC3E}">
        <p14:creationId xmlns:p14="http://schemas.microsoft.com/office/powerpoint/2010/main" val="27963414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D0522A8-73FF-3347-AFF3-A958F94A7AC2}"/>
              </a:ext>
            </a:extLst>
          </p:cNvPr>
          <p:cNvSpPr txBox="1"/>
          <p:nvPr/>
        </p:nvSpPr>
        <p:spPr>
          <a:xfrm>
            <a:off x="0" y="-4175"/>
            <a:ext cx="68579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H" sz="1600" dirty="0"/>
              <a:t>Uncropped western blot from figure 1B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1E187287-5FD2-0B4A-BE02-BB26CAED89E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3093"/>
          <a:stretch/>
        </p:blipFill>
        <p:spPr>
          <a:xfrm>
            <a:off x="0" y="334378"/>
            <a:ext cx="6860181" cy="9544985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55E67FC0-3457-8A48-B108-2DD1B64B2181}"/>
              </a:ext>
            </a:extLst>
          </p:cNvPr>
          <p:cNvSpPr/>
          <p:nvPr/>
        </p:nvSpPr>
        <p:spPr>
          <a:xfrm>
            <a:off x="3062176" y="786809"/>
            <a:ext cx="715926" cy="17295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H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51DF397B-4511-3A44-A757-753EFA17A9A7}"/>
              </a:ext>
            </a:extLst>
          </p:cNvPr>
          <p:cNvSpPr/>
          <p:nvPr/>
        </p:nvSpPr>
        <p:spPr>
          <a:xfrm rot="195726">
            <a:off x="3004072" y="3154282"/>
            <a:ext cx="766852" cy="17295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H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62AED200-B82A-FD4E-975C-BE753C94C5E2}"/>
              </a:ext>
            </a:extLst>
          </p:cNvPr>
          <p:cNvSpPr/>
          <p:nvPr/>
        </p:nvSpPr>
        <p:spPr>
          <a:xfrm rot="271019">
            <a:off x="3014804" y="5478523"/>
            <a:ext cx="766852" cy="163700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H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2BFAB36F-7BE8-F348-A405-C4AC12D02EAC}"/>
              </a:ext>
            </a:extLst>
          </p:cNvPr>
          <p:cNvSpPr/>
          <p:nvPr/>
        </p:nvSpPr>
        <p:spPr>
          <a:xfrm>
            <a:off x="3118884" y="7254160"/>
            <a:ext cx="567069" cy="15566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H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D85CB8F-3588-CF4E-81B4-C5B439D8A312}"/>
              </a:ext>
            </a:extLst>
          </p:cNvPr>
          <p:cNvSpPr txBox="1"/>
          <p:nvPr/>
        </p:nvSpPr>
        <p:spPr>
          <a:xfrm>
            <a:off x="498377" y="467096"/>
            <a:ext cx="4844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600" dirty="0"/>
              <a:t>Alix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16CCA9A-62B2-EB4B-8BA7-BEA68219CEF5}"/>
              </a:ext>
            </a:extLst>
          </p:cNvPr>
          <p:cNvSpPr txBox="1"/>
          <p:nvPr/>
        </p:nvSpPr>
        <p:spPr>
          <a:xfrm>
            <a:off x="498377" y="1013635"/>
            <a:ext cx="13934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600" dirty="0"/>
              <a:t>Synaptophysin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3EE3222-7849-294B-AAB5-6E183A0C98C0}"/>
              </a:ext>
            </a:extLst>
          </p:cNvPr>
          <p:cNvSpPr txBox="1"/>
          <p:nvPr/>
        </p:nvSpPr>
        <p:spPr>
          <a:xfrm>
            <a:off x="498377" y="723750"/>
            <a:ext cx="7200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600" dirty="0"/>
              <a:t>PSD95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B2FDEB9-0C2C-9E4B-BE16-9C6EE02214B2}"/>
              </a:ext>
            </a:extLst>
          </p:cNvPr>
          <p:cNvSpPr txBox="1"/>
          <p:nvPr/>
        </p:nvSpPr>
        <p:spPr>
          <a:xfrm>
            <a:off x="498377" y="1296804"/>
            <a:ext cx="6145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600" dirty="0"/>
              <a:t>P-erk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DE3222B2-A74E-6D4B-BA64-2E5CD73E78B7}"/>
              </a:ext>
            </a:extLst>
          </p:cNvPr>
          <p:cNvCxnSpPr>
            <a:cxnSpLocks/>
          </p:cNvCxnSpPr>
          <p:nvPr/>
        </p:nvCxnSpPr>
        <p:spPr>
          <a:xfrm>
            <a:off x="2031446" y="1218098"/>
            <a:ext cx="219112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A2090960-7799-FF41-AEEA-E486C9E384B2}"/>
              </a:ext>
            </a:extLst>
          </p:cNvPr>
          <p:cNvCxnSpPr>
            <a:cxnSpLocks/>
          </p:cNvCxnSpPr>
          <p:nvPr/>
        </p:nvCxnSpPr>
        <p:spPr>
          <a:xfrm>
            <a:off x="2031446" y="1639857"/>
            <a:ext cx="219112" cy="0"/>
          </a:xfrm>
          <a:prstGeom prst="straightConnector1">
            <a:avLst/>
          </a:prstGeom>
          <a:ln>
            <a:solidFill>
              <a:srgbClr val="00206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5579F8C7-0D5C-5E4B-A463-990432DA6B1C}"/>
              </a:ext>
            </a:extLst>
          </p:cNvPr>
          <p:cNvCxnSpPr>
            <a:cxnSpLocks/>
          </p:cNvCxnSpPr>
          <p:nvPr/>
        </p:nvCxnSpPr>
        <p:spPr>
          <a:xfrm>
            <a:off x="2031446" y="1919847"/>
            <a:ext cx="219112" cy="0"/>
          </a:xfrm>
          <a:prstGeom prst="straightConnector1">
            <a:avLst/>
          </a:prstGeom>
          <a:ln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14442EF4-F8F6-8543-9F80-A034CA0098C5}"/>
              </a:ext>
            </a:extLst>
          </p:cNvPr>
          <p:cNvCxnSpPr>
            <a:cxnSpLocks/>
          </p:cNvCxnSpPr>
          <p:nvPr/>
        </p:nvCxnSpPr>
        <p:spPr>
          <a:xfrm>
            <a:off x="2045622" y="3497010"/>
            <a:ext cx="219112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7C1CC18D-B4B1-6E4C-B394-46CFBACA87DB}"/>
              </a:ext>
            </a:extLst>
          </p:cNvPr>
          <p:cNvCxnSpPr>
            <a:cxnSpLocks/>
          </p:cNvCxnSpPr>
          <p:nvPr/>
        </p:nvCxnSpPr>
        <p:spPr>
          <a:xfrm>
            <a:off x="2045622" y="3918769"/>
            <a:ext cx="219112" cy="0"/>
          </a:xfrm>
          <a:prstGeom prst="straightConnector1">
            <a:avLst/>
          </a:prstGeom>
          <a:ln>
            <a:solidFill>
              <a:srgbClr val="00206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6FE297CF-8504-A049-A197-1031DE42392A}"/>
              </a:ext>
            </a:extLst>
          </p:cNvPr>
          <p:cNvCxnSpPr>
            <a:cxnSpLocks/>
          </p:cNvCxnSpPr>
          <p:nvPr/>
        </p:nvCxnSpPr>
        <p:spPr>
          <a:xfrm>
            <a:off x="2045622" y="4198759"/>
            <a:ext cx="219112" cy="0"/>
          </a:xfrm>
          <a:prstGeom prst="straightConnector1">
            <a:avLst/>
          </a:prstGeom>
          <a:ln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19E68235-FA9B-6942-A3FA-9A8DB1B7B577}"/>
              </a:ext>
            </a:extLst>
          </p:cNvPr>
          <p:cNvCxnSpPr>
            <a:cxnSpLocks/>
          </p:cNvCxnSpPr>
          <p:nvPr/>
        </p:nvCxnSpPr>
        <p:spPr>
          <a:xfrm>
            <a:off x="1974742" y="6059457"/>
            <a:ext cx="219112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31BB5C41-1D65-9841-807D-FBC3F2E38C27}"/>
              </a:ext>
            </a:extLst>
          </p:cNvPr>
          <p:cNvCxnSpPr>
            <a:cxnSpLocks/>
          </p:cNvCxnSpPr>
          <p:nvPr/>
        </p:nvCxnSpPr>
        <p:spPr>
          <a:xfrm>
            <a:off x="1974742" y="6481216"/>
            <a:ext cx="219112" cy="0"/>
          </a:xfrm>
          <a:prstGeom prst="straightConnector1">
            <a:avLst/>
          </a:prstGeom>
          <a:ln>
            <a:solidFill>
              <a:srgbClr val="00206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A9BEF6F3-C33F-234E-B34D-332F37215A4D}"/>
              </a:ext>
            </a:extLst>
          </p:cNvPr>
          <p:cNvCxnSpPr>
            <a:cxnSpLocks/>
          </p:cNvCxnSpPr>
          <p:nvPr/>
        </p:nvCxnSpPr>
        <p:spPr>
          <a:xfrm>
            <a:off x="1974742" y="6761206"/>
            <a:ext cx="219112" cy="0"/>
          </a:xfrm>
          <a:prstGeom prst="straightConnector1">
            <a:avLst/>
          </a:prstGeom>
          <a:ln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41A0FC74-CB10-0F48-8328-4F7D19F66DC6}"/>
              </a:ext>
            </a:extLst>
          </p:cNvPr>
          <p:cNvCxnSpPr>
            <a:cxnSpLocks/>
          </p:cNvCxnSpPr>
          <p:nvPr/>
        </p:nvCxnSpPr>
        <p:spPr>
          <a:xfrm>
            <a:off x="2843064" y="8586462"/>
            <a:ext cx="219112" cy="0"/>
          </a:xfrm>
          <a:prstGeom prst="straightConnector1">
            <a:avLst/>
          </a:prstGeom>
          <a:ln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91FA9F1E-7051-9C4C-923A-148461FE6211}"/>
              </a:ext>
            </a:extLst>
          </p:cNvPr>
          <p:cNvCxnSpPr>
            <a:cxnSpLocks/>
          </p:cNvCxnSpPr>
          <p:nvPr/>
        </p:nvCxnSpPr>
        <p:spPr>
          <a:xfrm>
            <a:off x="291288" y="668749"/>
            <a:ext cx="219112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97F2867B-6901-804A-AEE9-960DBCCFE6E6}"/>
              </a:ext>
            </a:extLst>
          </p:cNvPr>
          <p:cNvCxnSpPr>
            <a:cxnSpLocks/>
          </p:cNvCxnSpPr>
          <p:nvPr/>
        </p:nvCxnSpPr>
        <p:spPr>
          <a:xfrm>
            <a:off x="291288" y="906211"/>
            <a:ext cx="219112" cy="0"/>
          </a:xfrm>
          <a:prstGeom prst="straightConnector1">
            <a:avLst/>
          </a:prstGeom>
          <a:ln>
            <a:solidFill>
              <a:srgbClr val="00206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F18D1577-4F82-BA4D-A787-7F908E7FAA45}"/>
              </a:ext>
            </a:extLst>
          </p:cNvPr>
          <p:cNvCxnSpPr>
            <a:cxnSpLocks/>
          </p:cNvCxnSpPr>
          <p:nvPr/>
        </p:nvCxnSpPr>
        <p:spPr>
          <a:xfrm>
            <a:off x="291288" y="1186201"/>
            <a:ext cx="219112" cy="0"/>
          </a:xfrm>
          <a:prstGeom prst="straightConnector1">
            <a:avLst/>
          </a:prstGeom>
          <a:ln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63531E53-C9CA-0242-8DB1-F8EA7BD844C8}"/>
              </a:ext>
            </a:extLst>
          </p:cNvPr>
          <p:cNvCxnSpPr>
            <a:cxnSpLocks/>
          </p:cNvCxnSpPr>
          <p:nvPr/>
        </p:nvCxnSpPr>
        <p:spPr>
          <a:xfrm>
            <a:off x="291288" y="1473279"/>
            <a:ext cx="219112" cy="0"/>
          </a:xfrm>
          <a:prstGeom prst="straightConnector1">
            <a:avLst/>
          </a:prstGeom>
          <a:ln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81033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</TotalTime>
  <Words>54</Words>
  <Application>Microsoft Macintosh PowerPoint</Application>
  <PresentationFormat>A4 Paper (210x297 mm)</PresentationFormat>
  <Paragraphs>4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ne Laporte</dc:creator>
  <cp:lastModifiedBy>Marine Laporte</cp:lastModifiedBy>
  <cp:revision>1</cp:revision>
  <dcterms:created xsi:type="dcterms:W3CDTF">2022-04-13T11:40:08Z</dcterms:created>
  <dcterms:modified xsi:type="dcterms:W3CDTF">2022-04-13T12:06:05Z</dcterms:modified>
</cp:coreProperties>
</file>